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2" r:id="rId2"/>
  </p:sldIdLst>
  <p:sldSz cx="9144000" cy="5143500" type="screen16x9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2AFE"/>
    <a:srgbClr val="FB8F8F"/>
    <a:srgbClr val="FA626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118" autoAdjust="0"/>
  </p:normalViewPr>
  <p:slideViewPr>
    <p:cSldViewPr>
      <p:cViewPr varScale="1">
        <p:scale>
          <a:sx n="151" d="100"/>
          <a:sy n="151" d="100"/>
        </p:scale>
        <p:origin x="456" y="13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65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58C5EA-CBAC-4017-ACFF-2B1A2C6048AE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241B51-0E1A-4DF8-B3AC-5B6E0E81C6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84235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61F7290-15FB-97D9-367C-FD5BA9C0DA0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F7F18D60-2852-D21F-A2C7-241C2CE37377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7A9D8FD2-A091-1618-96E8-A3B8F7040C29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DE9767A-1B71-CD6A-8550-80A916716DF7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B4789EE-03BA-488C-834F-ECA9E8E7008D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2123539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0336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22708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05979"/>
            <a:ext cx="2057400" cy="4388644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05979"/>
            <a:ext cx="6019800" cy="4388644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6501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9063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8870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2892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6228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80628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6817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68921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16EBC-6DE9-4FE0-AFBA-6DE2A0BB2DFE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2345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05978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A16EBC-6DE9-4FE0-AFBA-6DE2A0BB2DFE}" type="datetimeFigureOut">
              <a:rPr kumimoji="1" lang="ja-JP" altLang="en-US" smtClean="0"/>
              <a:t>2026/2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378FA7-B6DE-4E1A-B5F3-B3A791E51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19311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2A39C1F-AE1F-57D4-D35F-E283F8327F6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6C55A483-AC50-99A8-4A2A-FEF29ACC5FB3}"/>
              </a:ext>
            </a:extLst>
          </p:cNvPr>
          <p:cNvGraphicFramePr>
            <a:graphicFrameLocks noGrp="1"/>
          </p:cNvGraphicFramePr>
          <p:nvPr/>
        </p:nvGraphicFramePr>
        <p:xfrm>
          <a:off x="1763688" y="451425"/>
          <a:ext cx="6192687" cy="3377665"/>
        </p:xfrm>
        <a:graphic>
          <a:graphicData uri="http://schemas.openxmlformats.org/drawingml/2006/table">
            <a:tbl>
              <a:tblPr/>
              <a:tblGrid>
                <a:gridCol w="258798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01566">
                  <a:extLst>
                    <a:ext uri="{9D8B030D-6E8A-4147-A177-3AD203B41FA5}">
                      <a16:colId xmlns:a16="http://schemas.microsoft.com/office/drawing/2014/main" val="1536457615"/>
                    </a:ext>
                  </a:extLst>
                </a:gridCol>
                <a:gridCol w="1201566">
                  <a:extLst>
                    <a:ext uri="{9D8B030D-6E8A-4147-A177-3AD203B41FA5}">
                      <a16:colId xmlns:a16="http://schemas.microsoft.com/office/drawing/2014/main" val="3704847076"/>
                    </a:ext>
                  </a:extLst>
                </a:gridCol>
                <a:gridCol w="1201566">
                  <a:extLst>
                    <a:ext uri="{9D8B030D-6E8A-4147-A177-3AD203B41FA5}">
                      <a16:colId xmlns:a16="http://schemas.microsoft.com/office/drawing/2014/main" val="4112324373"/>
                    </a:ext>
                  </a:extLst>
                </a:gridCol>
              </a:tblGrid>
              <a:tr h="218213"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Excluded participants 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Included participants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8213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Number of participants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5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P 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6507405"/>
                  </a:ext>
                </a:extLst>
              </a:tr>
              <a:tr h="2182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Age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(years) 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6 (44-6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3 (37-6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05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821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BMI</a:t>
                      </a: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 (kg/m</a:t>
                      </a:r>
                      <a:r>
                        <a:rPr lang="en-US" sz="10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23.6 (21.9-25.6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23.2 (21.4-25.1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0.381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0653972"/>
                  </a:ext>
                </a:extLst>
              </a:tr>
              <a:tr h="218213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SMI (kg/m</a:t>
                      </a:r>
                      <a:r>
                        <a:rPr lang="en-US" altLang="ja-JP" sz="10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.14 (7.6-8.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.1 (7.6-8.8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99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6789731"/>
                  </a:ext>
                </a:extLst>
              </a:tr>
              <a:tr h="2182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Serum albumin level (g/dL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4.5 (4.3-4.8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4.6 (4.4-4.8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0.066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4646655"/>
                  </a:ext>
                </a:extLst>
              </a:tr>
              <a:tr h="2182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AMS scale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27 (22-35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26 (21-32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0.170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6565723"/>
                  </a:ext>
                </a:extLst>
              </a:tr>
              <a:tr h="2182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eGFR (mL/min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/1.73</a:t>
                      </a: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m²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80.9 (72.8-88.6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80.5 (71.4-88.1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0.569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8749618"/>
                  </a:ext>
                </a:extLst>
              </a:tr>
              <a:tr h="2182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HbA1c (%) 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5.6 (5.4-5.9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5.6</a:t>
                      </a:r>
                      <a:r>
                        <a:rPr lang="en-US" altLang="ja-JP" sz="105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 (5.4-5.9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50" charset="-128"/>
                        <a:cs typeface="Arial" panose="020B0604020202020204" pitchFamily="34" charset="0"/>
                      </a:endParaRP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0.789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1661985"/>
                  </a:ext>
                </a:extLst>
              </a:tr>
              <a:tr h="2182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Total IPSS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 (1-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 (1-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27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4572338"/>
                  </a:ext>
                </a:extLst>
              </a:tr>
              <a:tr h="2182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Total OABSS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 (1-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 (0-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25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5984517"/>
                  </a:ext>
                </a:extLst>
              </a:tr>
              <a:tr h="2182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METs Daily exercise/week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 (0-6.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 (0-3.5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6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18213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Serum testosterone level (ng/dL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599 (478-782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589 (446-729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0.147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18213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Percent body fat</a:t>
                      </a:r>
                      <a:r>
                        <a:rPr lang="ja-JP" alt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(%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20.0 (16.0-24.5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19.3 (15.5-22.1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0.203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4217704"/>
                  </a:ext>
                </a:extLst>
              </a:tr>
              <a:tr h="218213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Serum IL-6 level (</a:t>
                      </a:r>
                      <a:r>
                        <a:rPr lang="en-US" altLang="ja-JP" sz="10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pg</a:t>
                      </a:r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/mL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1.11 (0.76-1.78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0.99 (0.68-1.46)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50" charset="-128"/>
                          <a:cs typeface="Arial" panose="020B0604020202020204" pitchFamily="34" charset="0"/>
                        </a:rPr>
                        <a:t>0.241</a:t>
                      </a:r>
                    </a:p>
                  </a:txBody>
                  <a:tcPr marL="2643" marR="2643" marT="26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7905469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AA128DE-9A1C-A86C-8E7E-45CFB5468912}"/>
              </a:ext>
            </a:extLst>
          </p:cNvPr>
          <p:cNvSpPr txBox="1"/>
          <p:nvPr/>
        </p:nvSpPr>
        <p:spPr>
          <a:xfrm>
            <a:off x="0" y="0"/>
            <a:ext cx="82695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5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able S</a:t>
            </a:r>
            <a:endParaRPr kumimoji="1" lang="ja-JP" altLang="en-US" sz="15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B6B58FE-C107-0BE1-A1EC-8845EE14B425}"/>
              </a:ext>
            </a:extLst>
          </p:cNvPr>
          <p:cNvSpPr txBox="1"/>
          <p:nvPr/>
        </p:nvSpPr>
        <p:spPr>
          <a:xfrm>
            <a:off x="1979712" y="41448"/>
            <a:ext cx="590465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3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Baseline characteristics between</a:t>
            </a:r>
            <a:r>
              <a:rPr lang="en-US" altLang="ja-JP" sz="1350" b="1" dirty="0">
                <a:solidFill>
                  <a:prstClr val="black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excluded and included participants</a:t>
            </a:r>
            <a:endParaRPr kumimoji="1" lang="ja-JP" altLang="en-US" sz="135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DC660B7-F5CD-583E-55B3-B60AFEC0A9D7}"/>
              </a:ext>
            </a:extLst>
          </p:cNvPr>
          <p:cNvSpPr txBox="1"/>
          <p:nvPr/>
        </p:nvSpPr>
        <p:spPr>
          <a:xfrm>
            <a:off x="1259632" y="3988348"/>
            <a:ext cx="7457509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88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MI, body mass index; SMI, skeletal muscle mass; AMS, Aging Males' Symptoms; eGFR, estimated Glomerular Filtration Rate; HbA1c, Hemoglobin A1c; IPSS, International Prostate Symptom Score; OAB, overactive bladder; METs; metabolic equivalents, IL-6, interleukin-6. </a:t>
            </a:r>
            <a:endParaRPr kumimoji="1" lang="ja-JP" altLang="en-US" sz="788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A2D551C-3CF7-C689-1BE7-E688CCB90CAF}"/>
              </a:ext>
            </a:extLst>
          </p:cNvPr>
          <p:cNvSpPr txBox="1"/>
          <p:nvPr/>
        </p:nvSpPr>
        <p:spPr>
          <a:xfrm>
            <a:off x="6121569" y="4335089"/>
            <a:ext cx="302367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Values are presented as median (Interquartile range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ann–Whitney U test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29725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80</TotalTime>
  <Words>270</Words>
  <Application>Microsoft Office PowerPoint</Application>
  <PresentationFormat>画面に合わせる (16:9)</PresentationFormat>
  <Paragraphs>6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 Unicode MS</vt:lpstr>
      <vt:lpstr>游ゴシック</vt:lpstr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岡本</dc:creator>
  <cp:lastModifiedBy>哲平 岡本</cp:lastModifiedBy>
  <cp:revision>166</cp:revision>
  <dcterms:created xsi:type="dcterms:W3CDTF">2020-01-13T06:14:36Z</dcterms:created>
  <dcterms:modified xsi:type="dcterms:W3CDTF">2026-02-09T08:54:57Z</dcterms:modified>
</cp:coreProperties>
</file>